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175A740-A10C-4749-967A-4C7AFBEEAABE}" v="46" dt="2021-09-20T20:22:29.0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2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is Hoyer" userId="8c378a1a5b622d94" providerId="LiveId" clId="{B175A740-A10C-4749-967A-4C7AFBEEAABE}"/>
    <pc:docChg chg="undo custSel addSld modSld">
      <pc:chgData name="Lois Hoyer" userId="8c378a1a5b622d94" providerId="LiveId" clId="{B175A740-A10C-4749-967A-4C7AFBEEAABE}" dt="2021-10-03T16:05:57.927" v="2969" actId="20577"/>
      <pc:docMkLst>
        <pc:docMk/>
      </pc:docMkLst>
      <pc:sldChg chg="addSp delSp modSp mod">
        <pc:chgData name="Lois Hoyer" userId="8c378a1a5b622d94" providerId="LiveId" clId="{B175A740-A10C-4749-967A-4C7AFBEEAABE}" dt="2021-10-03T16:05:48.088" v="2963" actId="20577"/>
        <pc:sldMkLst>
          <pc:docMk/>
          <pc:sldMk cId="380902020" sldId="256"/>
        </pc:sldMkLst>
        <pc:spChg chg="mod topLvl">
          <ac:chgData name="Lois Hoyer" userId="8c378a1a5b622d94" providerId="LiveId" clId="{B175A740-A10C-4749-967A-4C7AFBEEAABE}" dt="2021-09-20T20:21:56.114" v="2788" actId="338"/>
          <ac:spMkLst>
            <pc:docMk/>
            <pc:sldMk cId="380902020" sldId="256"/>
            <ac:spMk id="4" creationId="{2647DDF4-759B-481A-ABF3-7AA8F7097C11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5" creationId="{64C3A0DE-2C91-4535-AF7A-394814E83416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6" creationId="{2C30B5B3-7C20-4A72-AE5A-16CC182652BF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7" creationId="{1788274D-7DAA-4CB4-B7FC-0D3AC7589C34}"/>
          </ac:spMkLst>
        </pc:spChg>
        <pc:spChg chg="del mod topLvl">
          <ac:chgData name="Lois Hoyer" userId="8c378a1a5b622d94" providerId="LiveId" clId="{B175A740-A10C-4749-967A-4C7AFBEEAABE}" dt="2021-09-07T13:52:23.272" v="400" actId="478"/>
          <ac:spMkLst>
            <pc:docMk/>
            <pc:sldMk cId="380902020" sldId="256"/>
            <ac:spMk id="8" creationId="{3584E819-1072-44B5-AD29-2BC2E3E3F614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9" creationId="{0EA8121A-2563-4FAB-9306-905C2FBAE103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0" creationId="{671991C7-55BE-4B38-8499-4BC83CF330C2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1" creationId="{C53B7DEB-0242-4DA1-AD1A-18B89AB23B1B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2" creationId="{17A22548-54DF-40F4-84DC-95AB081A9103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3" creationId="{57EC84E6-98DA-45C6-8227-41F49A2CD02A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4" creationId="{DFD0AC64-0912-458A-B668-81CE91F1BF25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5" creationId="{14076AB1-52D6-41EC-ACB9-9146159F994F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6" creationId="{26159DAA-3378-4CFD-B48B-4085884F2CA5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7" creationId="{8B6CEA89-DEA2-4B7D-852D-630D11CF0599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8" creationId="{2B03AF00-5801-4B5C-9D1A-9B510178875B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9" creationId="{8ED943C0-4F00-4CE1-8CE0-E8D84A631131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0" creationId="{B6234098-4491-4151-8F6D-6566CCD8E1EF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1" creationId="{CF4C54DE-4B3F-4AC3-AB9C-C14045395109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2" creationId="{8AB1D928-8435-4347-AA6F-5EAD0778F64F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3" creationId="{AE88B02D-1F58-4D12-9B2F-104DE09B04E1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4" creationId="{2C365E4A-95A8-458B-A2ED-9C4B6A172947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5" creationId="{674B89E5-5CA4-44B1-925B-516FC21D429F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6" creationId="{DCD11C46-4AD5-4580-B4DA-978CCC459D5A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7" creationId="{02795E41-B6F1-4E3F-B02D-BA18EC34DE78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28" creationId="{35E50ACA-C8DC-408A-9A4F-E42555A36035}"/>
          </ac:spMkLst>
        </pc:spChg>
        <pc:spChg chg="del mod topLvl">
          <ac:chgData name="Lois Hoyer" userId="8c378a1a5b622d94" providerId="LiveId" clId="{B175A740-A10C-4749-967A-4C7AFBEEAABE}" dt="2021-09-07T13:52:22.606" v="399" actId="478"/>
          <ac:spMkLst>
            <pc:docMk/>
            <pc:sldMk cId="380902020" sldId="256"/>
            <ac:spMk id="29" creationId="{F0C53207-1C06-4CAF-9368-D198DD1B2D26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30" creationId="{2A64D5B1-0F40-4700-BB87-3277C3CC7364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31" creationId="{E545F580-95A5-4DA5-9676-9FEBAE0444BC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32" creationId="{E927BF54-6C30-460E-A4F0-208CDB67FE9E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33" creationId="{0A015689-3468-4E81-A48D-555E51C647F9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34" creationId="{5581D6BD-69D7-46ED-9B95-3B84806E3C35}"/>
          </ac:spMkLst>
        </pc:spChg>
        <pc:spChg chg="del mod topLvl">
          <ac:chgData name="Lois Hoyer" userId="8c378a1a5b622d94" providerId="LiveId" clId="{B175A740-A10C-4749-967A-4C7AFBEEAABE}" dt="2021-09-07T13:52:21.852" v="398" actId="478"/>
          <ac:spMkLst>
            <pc:docMk/>
            <pc:sldMk cId="380902020" sldId="256"/>
            <ac:spMk id="35" creationId="{12D30921-7CB7-42A4-9256-404970B5B152}"/>
          </ac:spMkLst>
        </pc:spChg>
        <pc:spChg chg="del mod topLvl">
          <ac:chgData name="Lois Hoyer" userId="8c378a1a5b622d94" providerId="LiveId" clId="{B175A740-A10C-4749-967A-4C7AFBEEAABE}" dt="2021-09-07T13:52:20.855" v="397" actId="478"/>
          <ac:spMkLst>
            <pc:docMk/>
            <pc:sldMk cId="380902020" sldId="256"/>
            <ac:spMk id="36" creationId="{5C807E02-4C81-4914-8CFA-988742247FA7}"/>
          </ac:spMkLst>
        </pc:spChg>
        <pc:spChg chg="del mod topLvl">
          <ac:chgData name="Lois Hoyer" userId="8c378a1a5b622d94" providerId="LiveId" clId="{B175A740-A10C-4749-967A-4C7AFBEEAABE}" dt="2021-09-07T13:52:18.574" v="396" actId="478"/>
          <ac:spMkLst>
            <pc:docMk/>
            <pc:sldMk cId="380902020" sldId="256"/>
            <ac:spMk id="37" creationId="{B1B5C760-FD2D-4D15-ACFA-2025FB0FE91E}"/>
          </ac:spMkLst>
        </pc:spChg>
        <pc:spChg chg="del mod topLvl">
          <ac:chgData name="Lois Hoyer" userId="8c378a1a5b622d94" providerId="LiveId" clId="{B175A740-A10C-4749-967A-4C7AFBEEAABE}" dt="2021-09-07T13:52:17.813" v="395" actId="478"/>
          <ac:spMkLst>
            <pc:docMk/>
            <pc:sldMk cId="380902020" sldId="256"/>
            <ac:spMk id="38" creationId="{4A25A915-E48D-4428-AD4D-9972145DC0DE}"/>
          </ac:spMkLst>
        </pc:spChg>
        <pc:spChg chg="del mod topLvl">
          <ac:chgData name="Lois Hoyer" userId="8c378a1a5b622d94" providerId="LiveId" clId="{B175A740-A10C-4749-967A-4C7AFBEEAABE}" dt="2021-09-07T13:52:16.366" v="394" actId="478"/>
          <ac:spMkLst>
            <pc:docMk/>
            <pc:sldMk cId="380902020" sldId="256"/>
            <ac:spMk id="39" creationId="{57B92455-0D78-43CE-8803-F04E921A4F8A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40" creationId="{ED77AD38-6AF4-4219-A01E-E9B07CC1DA30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41" creationId="{4AFC4CA9-AD5F-472A-971A-1CA4B23C367E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42" creationId="{C7E7A64E-6CC6-47A2-8B58-EEDE52FE46A7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43" creationId="{5B806C55-6CAB-4C17-8C05-9B7D8EE20487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44" creationId="{E1F38D94-51CF-4B8F-82CF-B18F4A0FEA9A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45" creationId="{90D3B040-D604-43FD-9575-738BF018FB6E}"/>
          </ac:spMkLst>
        </pc:spChg>
        <pc:spChg chg="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46" creationId="{0E18AE9F-10C1-4E5E-A44D-72DE10AAB00D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47" creationId="{B2E83ED4-51E8-4843-9413-0A607B240438}"/>
          </ac:spMkLst>
        </pc:spChg>
        <pc:spChg chg="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48" creationId="{E1CC8FBC-C940-4F8C-8B1D-269BFBEAFAB5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49" creationId="{816331E3-6B3E-4988-B5ED-58D0F087754D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0" creationId="{F8F2B976-4AE0-4D48-B594-8DF1973FFB2D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1" creationId="{0BAED963-EA20-4AA5-BB2C-7D6D04A30C4F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2" creationId="{851B09DB-0EE1-4757-B28A-266226E3369F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3" creationId="{F619A7EB-4154-4B8D-9DBD-65AA491B3089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4" creationId="{C2F67B9D-1FD1-4AF6-9F41-51BDA8E02D83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5" creationId="{84B27E5B-4DB8-4C6D-8824-BF1DE52CD93C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6" creationId="{20511B62-BD14-4229-8F45-9C9379B13F6B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7" creationId="{96C20C2A-8C3A-49D6-8B27-28B5F54E57F0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8" creationId="{60D80F0D-1204-47FF-8213-3CC400B614CE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59" creationId="{71C7E459-A645-4234-9D9C-88AF15417D0C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0" creationId="{26B8D77D-6694-49DE-B321-C04CB6BFAEFC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1" creationId="{8D648E33-59A1-4520-B546-50363BC0D7FE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2" creationId="{96DEB5E0-377A-4404-B038-519D9CDE22B3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3" creationId="{0640907E-9269-4BF2-80F6-BB82EBF37CB1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4" creationId="{3302CAD9-271F-42EB-A600-7E6ED2CA0B47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5" creationId="{756B6C94-39A7-4DF0-BD89-C2B7485C3688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6" creationId="{434FB8AB-15AC-4792-94C1-B518E9EB2B97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7" creationId="{6579CA24-4D39-4D13-9052-1069B15BC590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8" creationId="{41F16969-6017-49A4-8D9F-AE691C6F0E66}"/>
          </ac:spMkLst>
        </pc:spChg>
        <pc:spChg chg="add mod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68" creationId="{5EAE5B41-FD27-4F25-B545-260FF45BDEDF}"/>
          </ac:spMkLst>
        </pc:spChg>
        <pc:spChg chg="add mod topLvl">
          <ac:chgData name="Lois Hoyer" userId="8c378a1a5b622d94" providerId="LiveId" clId="{B175A740-A10C-4749-967A-4C7AFBEEAABE}" dt="2021-09-20T20:21:56.114" v="2788" actId="338"/>
          <ac:spMkLst>
            <pc:docMk/>
            <pc:sldMk cId="380902020" sldId="256"/>
            <ac:spMk id="69" creationId="{314643C1-F3A7-490C-81A7-163F141171E6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69" creationId="{F687A96F-8DBB-4F0C-8A75-7210BECB58C0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0" creationId="{7C73FD2F-92A5-43E6-84E5-D555DDC8BDA2}"/>
          </ac:spMkLst>
        </pc:spChg>
        <pc:spChg chg="add mod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70" creationId="{F1908149-5C16-4FE0-A525-9D8B373E5AB5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1" creationId="{A0BA3036-A571-4CC6-8C1A-A6D46C347849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2" creationId="{25D4EAB3-4275-4CD7-8436-5847D853BF0E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3" creationId="{E8B80CFE-6ADB-4B28-A55F-E206D28CFE6D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4" creationId="{E8F6A316-E6F2-4B0D-B30C-6370938FA7F2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5" creationId="{A05CC0FD-DDE9-463C-868E-DCE16D963B6B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6" creationId="{260966ED-EA91-4993-AD3F-149069F4EBAA}"/>
          </ac:spMkLst>
        </pc:spChg>
        <pc:spChg chg="add mod">
          <ac:chgData name="Lois Hoyer" userId="8c378a1a5b622d94" providerId="LiveId" clId="{B175A740-A10C-4749-967A-4C7AFBEEAABE}" dt="2021-09-20T20:22:20.418" v="2802" actId="1036"/>
          <ac:spMkLst>
            <pc:docMk/>
            <pc:sldMk cId="380902020" sldId="256"/>
            <ac:spMk id="77" creationId="{9D1587FB-109F-4062-81A4-48AA997C901E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7" creationId="{D928C57D-C42A-41A2-BF98-071C64A7286E}"/>
          </ac:spMkLst>
        </pc:spChg>
        <pc:spChg chg="add mod">
          <ac:chgData name="Lois Hoyer" userId="8c378a1a5b622d94" providerId="LiveId" clId="{B175A740-A10C-4749-967A-4C7AFBEEAABE}" dt="2021-09-20T20:22:02.959" v="2789" actId="1076"/>
          <ac:spMkLst>
            <pc:docMk/>
            <pc:sldMk cId="380902020" sldId="256"/>
            <ac:spMk id="78" creationId="{1364D96C-2D02-42BA-BDFF-BD72C91C85C8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8" creationId="{6933330D-4E50-4A3C-8E7A-233FB407868E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79" creationId="{0E3D681E-AE3C-4251-ABC7-4511E4A2620D}"/>
          </ac:spMkLst>
        </pc:spChg>
        <pc:spChg chg="add mod">
          <ac:chgData name="Lois Hoyer" userId="8c378a1a5b622d94" providerId="LiveId" clId="{B175A740-A10C-4749-967A-4C7AFBEEAABE}" dt="2021-09-20T20:22:29.046" v="2803" actId="1076"/>
          <ac:spMkLst>
            <pc:docMk/>
            <pc:sldMk cId="380902020" sldId="256"/>
            <ac:spMk id="79" creationId="{1E5BC7FB-CFCE-4CA0-8F30-3BA5EC6FE6A5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0" creationId="{2EED958C-125A-44D0-A8F6-F7A63AE0D8E3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1" creationId="{DE1AB3D8-0DC3-48C4-9A97-392F16653661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2" creationId="{9B167F42-ADE6-433E-9023-B58B4F15AB46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3" creationId="{01B73892-CE4B-491C-8703-971A718DFB4F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4" creationId="{142C2008-48C7-4489-831D-D57D1A81E0CA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5" creationId="{D987FC38-AE6F-4ED7-A814-4FB1FDC23BC9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6" creationId="{7C10356F-A067-438C-871A-5A69FA251C75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7" creationId="{A82104CA-CA6F-4644-BEE3-B9D187CCE7DD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8" creationId="{41AA6EFC-E493-4860-8FE6-504B0853E6F9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89" creationId="{C65A2AD6-32E1-4299-9C94-D1C21D3F3177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0" creationId="{1D416637-0704-4752-8F6C-9F11093F5B1F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1" creationId="{6C305552-993E-4B1C-BE20-7B8FCE9BC2CD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2" creationId="{0A97F099-E052-4A52-8D14-946C5D91E1F6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3" creationId="{7EE6519B-8DDE-4E16-8C85-0AD7D6A4C8D0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4" creationId="{E79F9B98-771F-40CA-BF41-9A788046639F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5" creationId="{4E298672-0C5F-43C7-B012-9813D3B69742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6" creationId="{9DEE6D81-D2C4-4171-B9D2-260852A4F560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7" creationId="{98683610-F16C-40DF-A175-7F34B217B41C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8" creationId="{95E0C0D7-D2CE-47F9-9265-5D1365DDE21C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99" creationId="{91A81DE8-12E8-4A60-9897-3118C7272438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0" creationId="{667B24FF-C2EA-4A02-8C2C-3A08434470A7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1" creationId="{2880956F-F11E-4718-8A2F-83F9B33729D8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2" creationId="{7D555809-E7EC-4BAD-B7BD-D1DE75CF431A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3" creationId="{58140FE2-B576-4DD7-B2ED-F25B47B0AE22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4" creationId="{56D9121C-706B-4EFF-AD26-227683EFDACF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5" creationId="{A2AA0264-C7D1-4ACF-A221-282AA2F559EA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6" creationId="{2C123B1D-0338-43D4-BC45-69F34A39C846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7" creationId="{B3576BDC-C3F2-4F94-9E02-55386B72BCC6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8" creationId="{1F7A20F3-362B-45B6-99B7-824996B6AC29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09" creationId="{11DDFB9B-845C-469C-8B0C-983E5CD6E2FE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10" creationId="{D0A22F11-304B-45B9-9CDF-F1917128620A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11" creationId="{B34DBF0E-4585-4834-9542-E3582A1123CF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12" creationId="{9D315F3E-64AF-4B9C-8E62-2D9DFEA212E6}"/>
          </ac:spMkLst>
        </pc:spChg>
        <pc:spChg chg="del mod topLvl">
          <ac:chgData name="Lois Hoyer" userId="8c378a1a5b622d94" providerId="LiveId" clId="{B175A740-A10C-4749-967A-4C7AFBEEAABE}" dt="2021-09-07T13:45:59.956" v="335" actId="478"/>
          <ac:spMkLst>
            <pc:docMk/>
            <pc:sldMk cId="380902020" sldId="256"/>
            <ac:spMk id="113" creationId="{94EF5E3A-26EF-47F2-B653-30947D82AD57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14" creationId="{7E0F1560-C29E-4073-9F75-68ACF0D10CE8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15" creationId="{A4120B7B-1062-48A4-92B0-A6B7DE0A752D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16" creationId="{84B325BC-23BA-42AC-A61B-F5BA8E08D919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17" creationId="{AD3045DA-26B3-416D-B589-425D37751EEF}"/>
          </ac:spMkLst>
        </pc:spChg>
        <pc:spChg chg="del mod topLvl">
          <ac:chgData name="Lois Hoyer" userId="8c378a1a5b622d94" providerId="LiveId" clId="{B175A740-A10C-4749-967A-4C7AFBEEAABE}" dt="2021-09-07T13:45:36.038" v="324" actId="478"/>
          <ac:spMkLst>
            <pc:docMk/>
            <pc:sldMk cId="380902020" sldId="256"/>
            <ac:spMk id="118" creationId="{45FED51F-C253-4509-BE45-D5C169B53156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19" creationId="{A64CD0E0-ECF7-4C99-B223-47ED965E18F2}"/>
          </ac:spMkLst>
        </pc:spChg>
        <pc:spChg chg="del mod topLvl">
          <ac:chgData name="Lois Hoyer" userId="8c378a1a5b622d94" providerId="LiveId" clId="{B175A740-A10C-4749-967A-4C7AFBEEAABE}" dt="2021-09-07T13:44:55.445" v="322" actId="478"/>
          <ac:spMkLst>
            <pc:docMk/>
            <pc:sldMk cId="380902020" sldId="256"/>
            <ac:spMk id="120" creationId="{BD5B035F-0678-4F40-91E5-D65C0342FA01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21" creationId="{4A7708C6-7334-4D20-AECE-8C59EAB423E8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22" creationId="{5A631DE6-4F56-485D-BDA2-89B41F74FC87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23" creationId="{77122AB3-B699-4E31-8495-4BBF6D32F44F}"/>
          </ac:spMkLst>
        </pc:spChg>
        <pc:spChg chg="mod topLvl">
          <ac:chgData name="Lois Hoyer" userId="8c378a1a5b622d94" providerId="LiveId" clId="{B175A740-A10C-4749-967A-4C7AFBEEAABE}" dt="2021-10-03T15:04:42.304" v="2953" actId="20577"/>
          <ac:spMkLst>
            <pc:docMk/>
            <pc:sldMk cId="380902020" sldId="256"/>
            <ac:spMk id="124" creationId="{3D6BAD10-97E9-45DE-8BBA-B3937CB27DD6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25" creationId="{9C6E7825-36E3-4C31-9FDF-7C6C07353111}"/>
          </ac:spMkLst>
        </pc:spChg>
        <pc:spChg chg="mod topLvl">
          <ac:chgData name="Lois Hoyer" userId="8c378a1a5b622d94" providerId="LiveId" clId="{B175A740-A10C-4749-967A-4C7AFBEEAABE}" dt="2021-09-20T20:03:09.603" v="2435" actId="165"/>
          <ac:spMkLst>
            <pc:docMk/>
            <pc:sldMk cId="380902020" sldId="256"/>
            <ac:spMk id="126" creationId="{C76E54CF-1C0A-4456-BCF5-DB83573196F2}"/>
          </ac:spMkLst>
        </pc:spChg>
        <pc:spChg chg="del mod">
          <ac:chgData name="Lois Hoyer" userId="8c378a1a5b622d94" providerId="LiveId" clId="{B175A740-A10C-4749-967A-4C7AFBEEAABE}" dt="2021-09-20T19:12:33.813" v="1539" actId="478"/>
          <ac:spMkLst>
            <pc:docMk/>
            <pc:sldMk cId="380902020" sldId="256"/>
            <ac:spMk id="127" creationId="{9236DBB7-5FA7-4F53-8055-CE02AC8180F2}"/>
          </ac:spMkLst>
        </pc:spChg>
        <pc:spChg chg="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28" creationId="{824E47CC-CB90-4275-94FC-18A57D89BF2E}"/>
          </ac:spMkLst>
        </pc:spChg>
        <pc:spChg chg="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29" creationId="{57130DC9-C168-406B-A671-4A916B5EE5CF}"/>
          </ac:spMkLst>
        </pc:spChg>
        <pc:spChg chg="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30" creationId="{D6F8BF60-A1E7-43DB-B7B9-ABA883130456}"/>
          </ac:spMkLst>
        </pc:spChg>
        <pc:spChg chg="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31" creationId="{87AB9E63-6A40-4ED1-B3AC-0A4639DEBB54}"/>
          </ac:spMkLst>
        </pc:spChg>
        <pc:spChg chg="del mod topLvl">
          <ac:chgData name="Lois Hoyer" userId="8c378a1a5b622d94" providerId="LiveId" clId="{B175A740-A10C-4749-967A-4C7AFBEEAABE}" dt="2021-09-07T13:44:53.903" v="321" actId="478"/>
          <ac:spMkLst>
            <pc:docMk/>
            <pc:sldMk cId="380902020" sldId="256"/>
            <ac:spMk id="132" creationId="{E2D503D4-FFBC-4F82-A622-5DE3F7798A70}"/>
          </ac:spMkLst>
        </pc:spChg>
        <pc:spChg chg="add 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43" creationId="{C47E2483-C54A-41E7-AA73-352842FB1411}"/>
          </ac:spMkLst>
        </pc:spChg>
        <pc:spChg chg="add 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44" creationId="{85D7181C-FAB7-45BF-BA71-34B092335DD1}"/>
          </ac:spMkLst>
        </pc:spChg>
        <pc:spChg chg="mod">
          <ac:chgData name="Lois Hoyer" userId="8c378a1a5b622d94" providerId="LiveId" clId="{B175A740-A10C-4749-967A-4C7AFBEEAABE}" dt="2021-10-03T16:05:48.088" v="2963" actId="20577"/>
          <ac:spMkLst>
            <pc:docMk/>
            <pc:sldMk cId="380902020" sldId="256"/>
            <ac:spMk id="145" creationId="{56603B88-69D2-4969-A0F8-CF996CB13C03}"/>
          </ac:spMkLst>
        </pc:spChg>
        <pc:spChg chg="add 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46" creationId="{37B65952-E15B-493B-B154-8E7B2C06B660}"/>
          </ac:spMkLst>
        </pc:spChg>
        <pc:spChg chg="add 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47" creationId="{96862306-C0E3-4BB9-82D2-C095A6393142}"/>
          </ac:spMkLst>
        </pc:spChg>
        <pc:spChg chg="add mod topLvl">
          <ac:chgData name="Lois Hoyer" userId="8c378a1a5b622d94" providerId="LiveId" clId="{B175A740-A10C-4749-967A-4C7AFBEEAABE}" dt="2021-09-20T20:03:15.142" v="2436" actId="165"/>
          <ac:spMkLst>
            <pc:docMk/>
            <pc:sldMk cId="380902020" sldId="256"/>
            <ac:spMk id="148" creationId="{2DD5EAD8-4FB2-456A-A086-02C5714BB7AF}"/>
          </ac:spMkLst>
        </pc:spChg>
        <pc:spChg chg="add mod topLvl">
          <ac:chgData name="Lois Hoyer" userId="8c378a1a5b622d94" providerId="LiveId" clId="{B175A740-A10C-4749-967A-4C7AFBEEAABE}" dt="2021-09-20T20:21:20.305" v="2786" actId="338"/>
          <ac:spMkLst>
            <pc:docMk/>
            <pc:sldMk cId="380902020" sldId="256"/>
            <ac:spMk id="149" creationId="{022BBC43-F5F1-411C-B0A8-FA9C6A5FEE73}"/>
          </ac:spMkLst>
        </pc:spChg>
        <pc:spChg chg="add mod">
          <ac:chgData name="Lois Hoyer" userId="8c378a1a5b622d94" providerId="LiveId" clId="{B175A740-A10C-4749-967A-4C7AFBEEAABE}" dt="2021-09-20T20:22:20.418" v="2802" actId="1036"/>
          <ac:spMkLst>
            <pc:docMk/>
            <pc:sldMk cId="380902020" sldId="256"/>
            <ac:spMk id="151" creationId="{75442BB6-9D73-4C3F-AE01-9003F768F22B}"/>
          </ac:spMkLst>
        </pc:spChg>
        <pc:grpChg chg="add del mod">
          <ac:chgData name="Lois Hoyer" userId="8c378a1a5b622d94" providerId="LiveId" clId="{B175A740-A10C-4749-967A-4C7AFBEEAABE}" dt="2021-09-10T21:33:49.028" v="1037" actId="165"/>
          <ac:grpSpMkLst>
            <pc:docMk/>
            <pc:sldMk cId="380902020" sldId="256"/>
            <ac:grpSpMk id="2" creationId="{28F226FA-D135-499D-9166-8B5999C35982}"/>
          </ac:grpSpMkLst>
        </pc:grpChg>
        <pc:grpChg chg="add mod">
          <ac:chgData name="Lois Hoyer" userId="8c378a1a5b622d94" providerId="LiveId" clId="{B175A740-A10C-4749-967A-4C7AFBEEAABE}" dt="2021-09-20T20:21:20.305" v="2786" actId="338"/>
          <ac:grpSpMkLst>
            <pc:docMk/>
            <pc:sldMk cId="380902020" sldId="256"/>
            <ac:grpSpMk id="2" creationId="{979811F7-6D69-46AB-8F0F-570FD893F200}"/>
          </ac:grpSpMkLst>
        </pc:grpChg>
        <pc:grpChg chg="mod">
          <ac:chgData name="Lois Hoyer" userId="8c378a1a5b622d94" providerId="LiveId" clId="{B175A740-A10C-4749-967A-4C7AFBEEAABE}" dt="2021-09-20T20:21:56.114" v="2788" actId="338"/>
          <ac:grpSpMkLst>
            <pc:docMk/>
            <pc:sldMk cId="380902020" sldId="256"/>
            <ac:grpSpMk id="3" creationId="{AACEBEBB-4724-4C7C-9D08-C694EEE8981B}"/>
          </ac:grpSpMkLst>
        </pc:grpChg>
        <pc:grpChg chg="add del mod">
          <ac:chgData name="Lois Hoyer" userId="8c378a1a5b622d94" providerId="LiveId" clId="{B175A740-A10C-4749-967A-4C7AFBEEAABE}" dt="2021-09-10T21:36:02.787" v="1064" actId="165"/>
          <ac:grpSpMkLst>
            <pc:docMk/>
            <pc:sldMk cId="380902020" sldId="256"/>
            <ac:grpSpMk id="3" creationId="{B9B4C08B-9CE7-478E-A344-FA3141E460BD}"/>
          </ac:grpSpMkLst>
        </pc:grpChg>
        <pc:grpChg chg="add mod topLvl">
          <ac:chgData name="Lois Hoyer" userId="8c378a1a5b622d94" providerId="LiveId" clId="{B175A740-A10C-4749-967A-4C7AFBEEAABE}" dt="2021-09-20T20:21:56.114" v="2788" actId="338"/>
          <ac:grpSpMkLst>
            <pc:docMk/>
            <pc:sldMk cId="380902020" sldId="256"/>
            <ac:grpSpMk id="8" creationId="{280237D8-C4FA-45B3-AC5F-0A4E12E9150F}"/>
          </ac:grpSpMkLst>
        </pc:grpChg>
        <pc:grpChg chg="add mod topLvl">
          <ac:chgData name="Lois Hoyer" userId="8c378a1a5b622d94" providerId="LiveId" clId="{B175A740-A10C-4749-967A-4C7AFBEEAABE}" dt="2021-09-20T20:21:56.114" v="2788" actId="338"/>
          <ac:grpSpMkLst>
            <pc:docMk/>
            <pc:sldMk cId="380902020" sldId="256"/>
            <ac:grpSpMk id="29" creationId="{122C6EE1-7C75-4DE7-ACA1-7B7478F3CB6E}"/>
          </ac:grpSpMkLst>
        </pc:grpChg>
        <pc:grpChg chg="add del mod topLvl">
          <ac:chgData name="Lois Hoyer" userId="8c378a1a5b622d94" providerId="LiveId" clId="{B175A740-A10C-4749-967A-4C7AFBEEAABE}" dt="2021-09-20T20:18:53.928" v="2450" actId="165"/>
          <ac:grpSpMkLst>
            <pc:docMk/>
            <pc:sldMk cId="380902020" sldId="256"/>
            <ac:grpSpMk id="35" creationId="{F965ECEF-489A-40B1-8B6F-F5625179E9E9}"/>
          </ac:grpSpMkLst>
        </pc:grpChg>
        <pc:grpChg chg="add del mod topLvl">
          <ac:chgData name="Lois Hoyer" userId="8c378a1a5b622d94" providerId="LiveId" clId="{B175A740-A10C-4749-967A-4C7AFBEEAABE}" dt="2021-09-20T20:03:20.129" v="2437" actId="165"/>
          <ac:grpSpMkLst>
            <pc:docMk/>
            <pc:sldMk cId="380902020" sldId="256"/>
            <ac:grpSpMk id="36" creationId="{AFF6B244-B0A9-4E90-AB2A-436822571BD2}"/>
          </ac:grpSpMkLst>
        </pc:grpChg>
        <pc:grpChg chg="add mod">
          <ac:chgData name="Lois Hoyer" userId="8c378a1a5b622d94" providerId="LiveId" clId="{B175A740-A10C-4749-967A-4C7AFBEEAABE}" dt="2021-09-20T20:03:15.142" v="2436" actId="165"/>
          <ac:grpSpMkLst>
            <pc:docMk/>
            <pc:sldMk cId="380902020" sldId="256"/>
            <ac:grpSpMk id="37" creationId="{1A3E89F4-C4B6-4841-8591-52F344026312}"/>
          </ac:grpSpMkLst>
        </pc:grpChg>
        <pc:grpChg chg="add mod topLvl">
          <ac:chgData name="Lois Hoyer" userId="8c378a1a5b622d94" providerId="LiveId" clId="{B175A740-A10C-4749-967A-4C7AFBEEAABE}" dt="2021-09-20T20:21:56.114" v="2788" actId="338"/>
          <ac:grpSpMkLst>
            <pc:docMk/>
            <pc:sldMk cId="380902020" sldId="256"/>
            <ac:grpSpMk id="38" creationId="{A4A5C4BE-FC8B-4552-8C1A-0E54BDF0379E}"/>
          </ac:grpSpMkLst>
        </pc:grpChg>
        <pc:grpChg chg="add mod">
          <ac:chgData name="Lois Hoyer" userId="8c378a1a5b622d94" providerId="LiveId" clId="{B175A740-A10C-4749-967A-4C7AFBEEAABE}" dt="2021-09-20T20:03:09.603" v="2435" actId="165"/>
          <ac:grpSpMkLst>
            <pc:docMk/>
            <pc:sldMk cId="380902020" sldId="256"/>
            <ac:grpSpMk id="39" creationId="{D072F30E-A8B9-426C-854B-8BDB9F66957A}"/>
          </ac:grpSpMkLst>
        </pc:grpChg>
        <pc:grpChg chg="add mod topLvl">
          <ac:chgData name="Lois Hoyer" userId="8c378a1a5b622d94" providerId="LiveId" clId="{B175A740-A10C-4749-967A-4C7AFBEEAABE}" dt="2021-09-20T20:21:56.114" v="2788" actId="338"/>
          <ac:grpSpMkLst>
            <pc:docMk/>
            <pc:sldMk cId="380902020" sldId="256"/>
            <ac:grpSpMk id="47" creationId="{83436C5B-FBAB-4ED0-808D-1EABD7739F82}"/>
          </ac:grpSpMkLst>
        </pc:grpChg>
        <pc:grpChg chg="add del mod topLvl">
          <ac:chgData name="Lois Hoyer" userId="8c378a1a5b622d94" providerId="LiveId" clId="{B175A740-A10C-4749-967A-4C7AFBEEAABE}" dt="2021-09-20T20:03:15.142" v="2436" actId="165"/>
          <ac:grpSpMkLst>
            <pc:docMk/>
            <pc:sldMk cId="380902020" sldId="256"/>
            <ac:grpSpMk id="49" creationId="{2C03C124-5C8D-4F14-BB43-AC38544271A4}"/>
          </ac:grpSpMkLst>
        </pc:grpChg>
        <pc:grpChg chg="add del mod">
          <ac:chgData name="Lois Hoyer" userId="8c378a1a5b622d94" providerId="LiveId" clId="{B175A740-A10C-4749-967A-4C7AFBEEAABE}" dt="2021-09-20T20:03:09.603" v="2435" actId="165"/>
          <ac:grpSpMkLst>
            <pc:docMk/>
            <pc:sldMk cId="380902020" sldId="256"/>
            <ac:grpSpMk id="50" creationId="{E8CB3B6C-E68D-46E5-85FB-E76FC0EECF1D}"/>
          </ac:grpSpMkLst>
        </pc:grpChg>
        <pc:grpChg chg="mod">
          <ac:chgData name="Lois Hoyer" userId="8c378a1a5b622d94" providerId="LiveId" clId="{B175A740-A10C-4749-967A-4C7AFBEEAABE}" dt="2021-09-20T20:21:56.114" v="2788" actId="338"/>
          <ac:grpSpMkLst>
            <pc:docMk/>
            <pc:sldMk cId="380902020" sldId="256"/>
            <ac:grpSpMk id="51" creationId="{0EA1792D-8B14-4DB2-BCDE-DB05BBE3AE3B}"/>
          </ac:grpSpMkLst>
        </pc:grpChg>
        <pc:grpChg chg="add mod">
          <ac:chgData name="Lois Hoyer" userId="8c378a1a5b622d94" providerId="LiveId" clId="{B175A740-A10C-4749-967A-4C7AFBEEAABE}" dt="2021-09-20T20:21:56.114" v="2788" actId="338"/>
          <ac:grpSpMkLst>
            <pc:docMk/>
            <pc:sldMk cId="380902020" sldId="256"/>
            <ac:grpSpMk id="52" creationId="{8919A49E-51AC-4362-BF51-08C018F2375B}"/>
          </ac:grpSpMkLst>
        </pc:grpChg>
        <pc:grpChg chg="del mod topLvl">
          <ac:chgData name="Lois Hoyer" userId="8c378a1a5b622d94" providerId="LiveId" clId="{B175A740-A10C-4749-967A-4C7AFBEEAABE}" dt="2021-09-06T21:40:23.715" v="57" actId="165"/>
          <ac:grpSpMkLst>
            <pc:docMk/>
            <pc:sldMk cId="380902020" sldId="256"/>
            <ac:grpSpMk id="133" creationId="{94263382-7985-4621-BE0B-1B6FA9ABC393}"/>
          </ac:grpSpMkLst>
        </pc:grpChg>
        <pc:grpChg chg="del mod topLvl">
          <ac:chgData name="Lois Hoyer" userId="8c378a1a5b622d94" providerId="LiveId" clId="{B175A740-A10C-4749-967A-4C7AFBEEAABE}" dt="2021-09-06T21:40:23.715" v="57" actId="165"/>
          <ac:grpSpMkLst>
            <pc:docMk/>
            <pc:sldMk cId="380902020" sldId="256"/>
            <ac:grpSpMk id="134" creationId="{9610969E-7A4C-45AB-8405-5BA146BDD319}"/>
          </ac:grpSpMkLst>
        </pc:grpChg>
        <pc:grpChg chg="add del mod">
          <ac:chgData name="Lois Hoyer" userId="8c378a1a5b622d94" providerId="LiveId" clId="{B175A740-A10C-4749-967A-4C7AFBEEAABE}" dt="2021-09-10T21:35:06.426" v="1046" actId="165"/>
          <ac:grpSpMkLst>
            <pc:docMk/>
            <pc:sldMk cId="380902020" sldId="256"/>
            <ac:grpSpMk id="135" creationId="{E2D325B5-28A0-4F0D-AAAB-D653BCB39011}"/>
          </ac:grpSpMkLst>
        </pc:grpChg>
        <pc:grpChg chg="del mod topLvl">
          <ac:chgData name="Lois Hoyer" userId="8c378a1a5b622d94" providerId="LiveId" clId="{B175A740-A10C-4749-967A-4C7AFBEEAABE}" dt="2021-09-06T21:40:23.715" v="57" actId="165"/>
          <ac:grpSpMkLst>
            <pc:docMk/>
            <pc:sldMk cId="380902020" sldId="256"/>
            <ac:grpSpMk id="136" creationId="{5FC6A1BE-C076-427E-B044-B090A59523BD}"/>
          </ac:grpSpMkLst>
        </pc:grpChg>
        <pc:grpChg chg="add del mod">
          <ac:chgData name="Lois Hoyer" userId="8c378a1a5b622d94" providerId="LiveId" clId="{B175A740-A10C-4749-967A-4C7AFBEEAABE}" dt="2021-09-10T21:37:53.982" v="1129" actId="165"/>
          <ac:grpSpMkLst>
            <pc:docMk/>
            <pc:sldMk cId="380902020" sldId="256"/>
            <ac:grpSpMk id="137" creationId="{81F6238D-D939-4072-9476-C4961866034B}"/>
          </ac:grpSpMkLst>
        </pc:grpChg>
        <pc:grpChg chg="del">
          <ac:chgData name="Lois Hoyer" userId="8c378a1a5b622d94" providerId="LiveId" clId="{B175A740-A10C-4749-967A-4C7AFBEEAABE}" dt="2021-09-07T13:42:24.623" v="318" actId="165"/>
          <ac:grpSpMkLst>
            <pc:docMk/>
            <pc:sldMk cId="380902020" sldId="256"/>
            <ac:grpSpMk id="139" creationId="{8ABA59C4-8339-4A46-87AC-865B0CF151E3}"/>
          </ac:grpSpMkLst>
        </pc:grpChg>
        <pc:grpChg chg="del mod topLvl">
          <ac:chgData name="Lois Hoyer" userId="8c378a1a5b622d94" providerId="LiveId" clId="{B175A740-A10C-4749-967A-4C7AFBEEAABE}" dt="2021-09-06T21:40:23.715" v="57" actId="165"/>
          <ac:grpSpMkLst>
            <pc:docMk/>
            <pc:sldMk cId="380902020" sldId="256"/>
            <ac:grpSpMk id="140" creationId="{B8C4411D-C052-4789-BD09-4AD130DE7BEA}"/>
          </ac:grpSpMkLst>
        </pc:grpChg>
        <pc:grpChg chg="del mod topLvl">
          <ac:chgData name="Lois Hoyer" userId="8c378a1a5b622d94" providerId="LiveId" clId="{B175A740-A10C-4749-967A-4C7AFBEEAABE}" dt="2021-09-06T21:40:15.714" v="56" actId="165"/>
          <ac:grpSpMkLst>
            <pc:docMk/>
            <pc:sldMk cId="380902020" sldId="256"/>
            <ac:grpSpMk id="141" creationId="{F27D7C4B-C8F3-49DB-B9C5-B037AE720144}"/>
          </ac:grpSpMkLst>
        </pc:grpChg>
        <pc:grpChg chg="del">
          <ac:chgData name="Lois Hoyer" userId="8c378a1a5b622d94" providerId="LiveId" clId="{B175A740-A10C-4749-967A-4C7AFBEEAABE}" dt="2021-09-06T21:40:07.631" v="55" actId="165"/>
          <ac:grpSpMkLst>
            <pc:docMk/>
            <pc:sldMk cId="380902020" sldId="256"/>
            <ac:grpSpMk id="142" creationId="{4D86054B-E1A2-4EE6-81B6-A2A638738D6B}"/>
          </ac:grpSpMkLst>
        </pc:grpChg>
        <pc:graphicFrameChg chg="add mod modGraphic">
          <ac:chgData name="Lois Hoyer" userId="8c378a1a5b622d94" providerId="LiveId" clId="{B175A740-A10C-4749-967A-4C7AFBEEAABE}" dt="2021-09-20T20:22:20.418" v="2802" actId="1036"/>
          <ac:graphicFrameMkLst>
            <pc:docMk/>
            <pc:sldMk cId="380902020" sldId="256"/>
            <ac:graphicFrameMk id="150" creationId="{F29A43A7-4395-4A63-88A7-A6C1F1828A08}"/>
          </ac:graphicFrameMkLst>
        </pc:graphicFrameChg>
      </pc:sldChg>
      <pc:sldChg chg="addSp delSp modSp new mod">
        <pc:chgData name="Lois Hoyer" userId="8c378a1a5b622d94" providerId="LiveId" clId="{B175A740-A10C-4749-967A-4C7AFBEEAABE}" dt="2021-10-03T16:05:57.927" v="2969" actId="20577"/>
        <pc:sldMkLst>
          <pc:docMk/>
          <pc:sldMk cId="3339563271" sldId="257"/>
        </pc:sldMkLst>
        <pc:spChg chg="del">
          <ac:chgData name="Lois Hoyer" userId="8c378a1a5b622d94" providerId="LiveId" clId="{B175A740-A10C-4749-967A-4C7AFBEEAABE}" dt="2021-09-20T19:08:30.131" v="1434" actId="478"/>
          <ac:spMkLst>
            <pc:docMk/>
            <pc:sldMk cId="3339563271" sldId="257"/>
            <ac:spMk id="2" creationId="{E13AD0B9-98ED-46F0-88ED-55E9F593B53D}"/>
          </ac:spMkLst>
        </pc:spChg>
        <pc:spChg chg="del">
          <ac:chgData name="Lois Hoyer" userId="8c378a1a5b622d94" providerId="LiveId" clId="{B175A740-A10C-4749-967A-4C7AFBEEAABE}" dt="2021-09-20T19:08:32.491" v="1435" actId="478"/>
          <ac:spMkLst>
            <pc:docMk/>
            <pc:sldMk cId="3339563271" sldId="257"/>
            <ac:spMk id="3" creationId="{82BBA790-ACCF-4D89-80A3-9BB1BAE50281}"/>
          </ac:spMkLst>
        </pc:spChg>
        <pc:spChg chg="add mod">
          <ac:chgData name="Lois Hoyer" userId="8c378a1a5b622d94" providerId="LiveId" clId="{B175A740-A10C-4749-967A-4C7AFBEEAABE}" dt="2021-10-03T16:05:57.927" v="2969" actId="20577"/>
          <ac:spMkLst>
            <pc:docMk/>
            <pc:sldMk cId="3339563271" sldId="257"/>
            <ac:spMk id="4" creationId="{AE574193-001F-4EB9-9CCB-6AE236996AE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491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4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977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5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67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642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767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413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938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381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2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132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Rectangle 3">
            <a:extLst>
              <a:ext uri="{FF2B5EF4-FFF2-40B4-BE49-F238E27FC236}">
                <a16:creationId xmlns:a16="http://schemas.microsoft.com/office/drawing/2014/main" id="{56603B88-69D2-4969-A0F8-CF996CB13C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8583" y="3271602"/>
            <a:ext cx="6093851" cy="107721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sensus tandem repeat sequence in each protein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uA</a:t>
            </a: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s4112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(35 aa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TPVTT_T_-T--WTG__T_TET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PSGGTE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V___V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uAls4112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(39 aa)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TST_YTTLTSTWTGS_T_T_T_PP_GSDTVGTVVVEV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</a:t>
            </a:r>
            <a:endParaRPr lang="en-US" altLang="en-US" sz="10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0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 Consensus (36 aa) 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VTTT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WS_S____T_T_T__P__T__V___E</a:t>
            </a:r>
            <a:endParaRPr lang="en-US" altLang="en-US" sz="1000" b="1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r Consensus (36 aa)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PT_T_T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_ ______T_T_______TD______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pCoCm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Consensus (36 aa)   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PT_T_T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 WTG____T_T_T__PG_TD_V_V__</a:t>
            </a:r>
          </a:p>
        </p:txBody>
      </p:sp>
      <p:graphicFrame>
        <p:nvGraphicFramePr>
          <p:cNvPr id="150" name="Table 149">
            <a:extLst>
              <a:ext uri="{FF2B5EF4-FFF2-40B4-BE49-F238E27FC236}">
                <a16:creationId xmlns:a16="http://schemas.microsoft.com/office/drawing/2014/main" id="{F29A43A7-4395-4A63-88A7-A6C1F1828A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3807994"/>
              </p:ext>
            </p:extLst>
          </p:nvPr>
        </p:nvGraphicFramePr>
        <p:xfrm>
          <a:off x="2316162" y="5263656"/>
          <a:ext cx="4511675" cy="8382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02335">
                  <a:extLst>
                    <a:ext uri="{9D8B030D-6E8A-4147-A177-3AD203B41FA5}">
                      <a16:colId xmlns:a16="http://schemas.microsoft.com/office/drawing/2014/main" val="2131190332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2509173655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1583704248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2936704474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29593781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uAls2582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uAls4112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uAls4498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828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uAls2582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9365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uAls4112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3419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uAls4498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2254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CaAls3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4973000"/>
                  </a:ext>
                </a:extLst>
              </a:tr>
            </a:tbl>
          </a:graphicData>
        </a:graphic>
      </p:graphicFrame>
      <p:sp>
        <p:nvSpPr>
          <p:cNvPr id="151" name="TextBox 150">
            <a:extLst>
              <a:ext uri="{FF2B5EF4-FFF2-40B4-BE49-F238E27FC236}">
                <a16:creationId xmlns:a16="http://schemas.microsoft.com/office/drawing/2014/main" id="{75442BB6-9D73-4C3F-AE01-9003F768F22B}"/>
              </a:ext>
            </a:extLst>
          </p:cNvPr>
          <p:cNvSpPr txBox="1"/>
          <p:nvPr/>
        </p:nvSpPr>
        <p:spPr>
          <a:xfrm>
            <a:off x="1949326" y="5023571"/>
            <a:ext cx="52453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ercent identity values for comparisons between NT-Als sequences in each protein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79811F7-6D69-46AB-8F0F-570FD893F200}"/>
              </a:ext>
            </a:extLst>
          </p:cNvPr>
          <p:cNvGrpSpPr/>
          <p:nvPr/>
        </p:nvGrpSpPr>
        <p:grpSpPr>
          <a:xfrm>
            <a:off x="1132765" y="1642111"/>
            <a:ext cx="4233452" cy="228600"/>
            <a:chOff x="1132765" y="1642111"/>
            <a:chExt cx="4233452" cy="228600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4C3A0DE-2C91-4535-AF7A-394814E83416}"/>
                </a:ext>
              </a:extLst>
            </p:cNvPr>
            <p:cNvSpPr/>
            <p:nvPr/>
          </p:nvSpPr>
          <p:spPr>
            <a:xfrm>
              <a:off x="1177292" y="1642111"/>
              <a:ext cx="896112" cy="2286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C30B5B3-7C20-4A72-AE5A-16CC182652BF}"/>
                </a:ext>
              </a:extLst>
            </p:cNvPr>
            <p:cNvSpPr/>
            <p:nvPr/>
          </p:nvSpPr>
          <p:spPr>
            <a:xfrm>
              <a:off x="5311353" y="1642111"/>
              <a:ext cx="54864" cy="228600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7030A0"/>
                </a:solidFill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1788274D-7DAA-4CB4-B7FC-0D3AC7589C34}"/>
                </a:ext>
              </a:extLst>
            </p:cNvPr>
            <p:cNvSpPr/>
            <p:nvPr/>
          </p:nvSpPr>
          <p:spPr>
            <a:xfrm>
              <a:off x="1132765" y="1642111"/>
              <a:ext cx="45720" cy="228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4"/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0EA8121A-2563-4FAB-9306-905C2FBAE103}"/>
                </a:ext>
              </a:extLst>
            </p:cNvPr>
            <p:cNvSpPr/>
            <p:nvPr/>
          </p:nvSpPr>
          <p:spPr>
            <a:xfrm>
              <a:off x="4615846" y="1642111"/>
              <a:ext cx="694944" cy="228600"/>
            </a:xfrm>
            <a:prstGeom prst="rect">
              <a:avLst/>
            </a:prstGeom>
            <a:solidFill>
              <a:srgbClr val="0066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671991C7-55BE-4B38-8499-4BC83CF330C2}"/>
                </a:ext>
              </a:extLst>
            </p:cNvPr>
            <p:cNvSpPr/>
            <p:nvPr/>
          </p:nvSpPr>
          <p:spPr>
            <a:xfrm>
              <a:off x="2078081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57EC84E6-98DA-45C6-8227-41F49A2CD02A}"/>
                </a:ext>
              </a:extLst>
            </p:cNvPr>
            <p:cNvSpPr/>
            <p:nvPr/>
          </p:nvSpPr>
          <p:spPr>
            <a:xfrm>
              <a:off x="2156176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FD0AC64-0912-458A-B668-81CE91F1BF25}"/>
                </a:ext>
              </a:extLst>
            </p:cNvPr>
            <p:cNvSpPr/>
            <p:nvPr/>
          </p:nvSpPr>
          <p:spPr>
            <a:xfrm>
              <a:off x="2234271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4076AB1-52D6-41EC-ACB9-9146159F994F}"/>
                </a:ext>
              </a:extLst>
            </p:cNvPr>
            <p:cNvSpPr/>
            <p:nvPr/>
          </p:nvSpPr>
          <p:spPr>
            <a:xfrm>
              <a:off x="2318412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6159DAA-3378-4CFD-B48B-4085884F2CA5}"/>
                </a:ext>
              </a:extLst>
            </p:cNvPr>
            <p:cNvSpPr/>
            <p:nvPr/>
          </p:nvSpPr>
          <p:spPr>
            <a:xfrm>
              <a:off x="2403043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8B6CEA89-DEA2-4B7D-852D-630D11CF0599}"/>
                </a:ext>
              </a:extLst>
            </p:cNvPr>
            <p:cNvSpPr/>
            <p:nvPr/>
          </p:nvSpPr>
          <p:spPr>
            <a:xfrm>
              <a:off x="2487674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2B03AF00-5801-4B5C-9D1A-9B510178875B}"/>
                </a:ext>
              </a:extLst>
            </p:cNvPr>
            <p:cNvSpPr/>
            <p:nvPr/>
          </p:nvSpPr>
          <p:spPr>
            <a:xfrm>
              <a:off x="2566695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8ED943C0-4F00-4CE1-8CE0-E8D84A631131}"/>
                </a:ext>
              </a:extLst>
            </p:cNvPr>
            <p:cNvSpPr/>
            <p:nvPr/>
          </p:nvSpPr>
          <p:spPr>
            <a:xfrm>
              <a:off x="2645717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B6234098-4491-4151-8F6D-6566CCD8E1EF}"/>
                </a:ext>
              </a:extLst>
            </p:cNvPr>
            <p:cNvSpPr/>
            <p:nvPr/>
          </p:nvSpPr>
          <p:spPr>
            <a:xfrm>
              <a:off x="2724737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F4C54DE-4B3F-4AC3-AB9C-C14045395109}"/>
                </a:ext>
              </a:extLst>
            </p:cNvPr>
            <p:cNvSpPr/>
            <p:nvPr/>
          </p:nvSpPr>
          <p:spPr>
            <a:xfrm>
              <a:off x="2803762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8AB1D928-8435-4347-AA6F-5EAD0778F64F}"/>
                </a:ext>
              </a:extLst>
            </p:cNvPr>
            <p:cNvSpPr/>
            <p:nvPr/>
          </p:nvSpPr>
          <p:spPr>
            <a:xfrm>
              <a:off x="2882783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AE88B02D-1F58-4D12-9B2F-104DE09B04E1}"/>
                </a:ext>
              </a:extLst>
            </p:cNvPr>
            <p:cNvSpPr/>
            <p:nvPr/>
          </p:nvSpPr>
          <p:spPr>
            <a:xfrm>
              <a:off x="3136676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C365E4A-95A8-458B-A2ED-9C4B6A172947}"/>
                </a:ext>
              </a:extLst>
            </p:cNvPr>
            <p:cNvSpPr/>
            <p:nvPr/>
          </p:nvSpPr>
          <p:spPr>
            <a:xfrm>
              <a:off x="3052045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674B89E5-5CA4-44B1-925B-516FC21D429F}"/>
                </a:ext>
              </a:extLst>
            </p:cNvPr>
            <p:cNvSpPr/>
            <p:nvPr/>
          </p:nvSpPr>
          <p:spPr>
            <a:xfrm>
              <a:off x="3221307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DCD11C46-4AD5-4580-B4DA-978CCC459D5A}"/>
                </a:ext>
              </a:extLst>
            </p:cNvPr>
            <p:cNvSpPr/>
            <p:nvPr/>
          </p:nvSpPr>
          <p:spPr>
            <a:xfrm>
              <a:off x="3554221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02795E41-B6F1-4E3F-B02D-BA18EC34DE78}"/>
                </a:ext>
              </a:extLst>
            </p:cNvPr>
            <p:cNvSpPr/>
            <p:nvPr/>
          </p:nvSpPr>
          <p:spPr>
            <a:xfrm>
              <a:off x="3390569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35E50ACA-C8DC-408A-9A4F-E42555A36035}"/>
                </a:ext>
              </a:extLst>
            </p:cNvPr>
            <p:cNvSpPr/>
            <p:nvPr/>
          </p:nvSpPr>
          <p:spPr>
            <a:xfrm>
              <a:off x="3305938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2A64D5B1-0F40-4700-BB87-3277C3CC7364}"/>
                </a:ext>
              </a:extLst>
            </p:cNvPr>
            <p:cNvSpPr/>
            <p:nvPr/>
          </p:nvSpPr>
          <p:spPr>
            <a:xfrm>
              <a:off x="4155791" y="1642111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E545F580-95A5-4DA5-9676-9FEBAE0444BC}"/>
                </a:ext>
              </a:extLst>
            </p:cNvPr>
            <p:cNvSpPr/>
            <p:nvPr/>
          </p:nvSpPr>
          <p:spPr>
            <a:xfrm>
              <a:off x="4247802" y="1642111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E927BF54-6C30-460E-A4F0-208CDB67FE9E}"/>
                </a:ext>
              </a:extLst>
            </p:cNvPr>
            <p:cNvSpPr/>
            <p:nvPr/>
          </p:nvSpPr>
          <p:spPr>
            <a:xfrm>
              <a:off x="4339813" y="1642111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0A015689-3468-4E81-A48D-555E51C647F9}"/>
                </a:ext>
              </a:extLst>
            </p:cNvPr>
            <p:cNvSpPr/>
            <p:nvPr/>
          </p:nvSpPr>
          <p:spPr>
            <a:xfrm>
              <a:off x="4431824" y="1642111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5581D6BD-69D7-46ED-9B95-3B84806E3C35}"/>
                </a:ext>
              </a:extLst>
            </p:cNvPr>
            <p:cNvSpPr/>
            <p:nvPr/>
          </p:nvSpPr>
          <p:spPr>
            <a:xfrm>
              <a:off x="4523835" y="1642111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ED77AD38-6AF4-4219-A01E-E9B07CC1DA30}"/>
                </a:ext>
              </a:extLst>
            </p:cNvPr>
            <p:cNvSpPr/>
            <p:nvPr/>
          </p:nvSpPr>
          <p:spPr>
            <a:xfrm>
              <a:off x="3971769" y="1642111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4AFC4CA9-AD5F-472A-971A-1CA4B23C367E}"/>
                </a:ext>
              </a:extLst>
            </p:cNvPr>
            <p:cNvSpPr/>
            <p:nvPr/>
          </p:nvSpPr>
          <p:spPr>
            <a:xfrm>
              <a:off x="4063780" y="1642111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C7E7A64E-6CC6-47A2-8B58-EEDE52FE46A7}"/>
                </a:ext>
              </a:extLst>
            </p:cNvPr>
            <p:cNvSpPr/>
            <p:nvPr/>
          </p:nvSpPr>
          <p:spPr>
            <a:xfrm>
              <a:off x="3887138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5B806C55-6CAB-4C17-8C05-9B7D8EE20487}"/>
                </a:ext>
              </a:extLst>
            </p:cNvPr>
            <p:cNvSpPr/>
            <p:nvPr/>
          </p:nvSpPr>
          <p:spPr>
            <a:xfrm>
              <a:off x="3805775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E1F38D94-51CF-4B8F-82CF-B18F4A0FEA9A}"/>
                </a:ext>
              </a:extLst>
            </p:cNvPr>
            <p:cNvSpPr/>
            <p:nvPr/>
          </p:nvSpPr>
          <p:spPr>
            <a:xfrm>
              <a:off x="3475200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90D3B040-D604-43FD-9575-738BF018FB6E}"/>
                </a:ext>
              </a:extLst>
            </p:cNvPr>
            <p:cNvSpPr/>
            <p:nvPr/>
          </p:nvSpPr>
          <p:spPr>
            <a:xfrm>
              <a:off x="3637441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0E18AE9F-10C1-4E5E-A44D-72DE10AAB00D}"/>
                </a:ext>
              </a:extLst>
            </p:cNvPr>
            <p:cNvSpPr/>
            <p:nvPr/>
          </p:nvSpPr>
          <p:spPr>
            <a:xfrm>
              <a:off x="3718802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022BBC43-F5F1-411C-B0A8-FA9C6A5FEE73}"/>
                </a:ext>
              </a:extLst>
            </p:cNvPr>
            <p:cNvSpPr/>
            <p:nvPr/>
          </p:nvSpPr>
          <p:spPr>
            <a:xfrm>
              <a:off x="2967414" y="1642111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8919A49E-51AC-4362-BF51-08C018F2375B}"/>
              </a:ext>
            </a:extLst>
          </p:cNvPr>
          <p:cNvGrpSpPr/>
          <p:nvPr/>
        </p:nvGrpSpPr>
        <p:grpSpPr>
          <a:xfrm>
            <a:off x="938850" y="909099"/>
            <a:ext cx="7443850" cy="1564414"/>
            <a:chOff x="938850" y="909099"/>
            <a:chExt cx="7443850" cy="1564414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280237D8-C4FA-45B3-AC5F-0A4E12E9150F}"/>
                </a:ext>
              </a:extLst>
            </p:cNvPr>
            <p:cNvGrpSpPr/>
            <p:nvPr/>
          </p:nvGrpSpPr>
          <p:grpSpPr>
            <a:xfrm>
              <a:off x="5825196" y="2227292"/>
              <a:ext cx="796712" cy="246221"/>
              <a:chOff x="6569756" y="2289765"/>
              <a:chExt cx="796712" cy="246221"/>
            </a:xfrm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C53B7DEB-0242-4DA1-AD1A-18B89AB23B1B}"/>
                  </a:ext>
                </a:extLst>
              </p:cNvPr>
              <p:cNvSpPr/>
              <p:nvPr/>
            </p:nvSpPr>
            <p:spPr>
              <a:xfrm>
                <a:off x="6569756" y="2294003"/>
                <a:ext cx="237744" cy="23774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7A22548-54DF-40F4-84DC-95AB081A9103}"/>
                  </a:ext>
                </a:extLst>
              </p:cNvPr>
              <p:cNvSpPr txBox="1"/>
              <p:nvPr/>
            </p:nvSpPr>
            <p:spPr>
              <a:xfrm>
                <a:off x="6793875" y="2289765"/>
                <a:ext cx="572593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 aa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83436C5B-FBAB-4ED0-808D-1EABD7739F82}"/>
                </a:ext>
              </a:extLst>
            </p:cNvPr>
            <p:cNvGrpSpPr/>
            <p:nvPr/>
          </p:nvGrpSpPr>
          <p:grpSpPr>
            <a:xfrm>
              <a:off x="6727478" y="1027575"/>
              <a:ext cx="1655222" cy="1055305"/>
              <a:chOff x="6376461" y="931866"/>
              <a:chExt cx="1655222" cy="1055305"/>
            </a:xfrm>
          </p:grpSpPr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7E0F1560-C29E-4073-9F75-68ACF0D10CE8}"/>
                  </a:ext>
                </a:extLst>
              </p:cNvPr>
              <p:cNvSpPr/>
              <p:nvPr/>
            </p:nvSpPr>
            <p:spPr>
              <a:xfrm>
                <a:off x="6477396" y="947856"/>
                <a:ext cx="152400" cy="152400"/>
              </a:xfrm>
              <a:prstGeom prst="rect">
                <a:avLst/>
              </a:prstGeom>
              <a:solidFill>
                <a:srgbClr val="FFC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15" name="Rectangle 114">
                <a:extLst>
                  <a:ext uri="{FF2B5EF4-FFF2-40B4-BE49-F238E27FC236}">
                    <a16:creationId xmlns:a16="http://schemas.microsoft.com/office/drawing/2014/main" id="{A4120B7B-1062-48A4-92B0-A6B7DE0A752D}"/>
                  </a:ext>
                </a:extLst>
              </p:cNvPr>
              <p:cNvSpPr/>
              <p:nvPr/>
            </p:nvSpPr>
            <p:spPr>
              <a:xfrm>
                <a:off x="6477396" y="1159861"/>
                <a:ext cx="152400" cy="1524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D072F30E-A8B9-426C-854B-8BDB9F66957A}"/>
                  </a:ext>
                </a:extLst>
              </p:cNvPr>
              <p:cNvGrpSpPr/>
              <p:nvPr/>
            </p:nvGrpSpPr>
            <p:grpSpPr>
              <a:xfrm>
                <a:off x="6376461" y="1371866"/>
                <a:ext cx="345695" cy="152400"/>
                <a:chOff x="6376461" y="1371560"/>
                <a:chExt cx="345695" cy="152400"/>
              </a:xfrm>
            </p:grpSpPr>
            <p:sp>
              <p:nvSpPr>
                <p:cNvPr id="116" name="Rectangle 115">
                  <a:extLst>
                    <a:ext uri="{FF2B5EF4-FFF2-40B4-BE49-F238E27FC236}">
                      <a16:creationId xmlns:a16="http://schemas.microsoft.com/office/drawing/2014/main" id="{84B325BC-23BA-42AC-A61B-F5BA8E08D919}"/>
                    </a:ext>
                  </a:extLst>
                </p:cNvPr>
                <p:cNvSpPr/>
                <p:nvPr/>
              </p:nvSpPr>
              <p:spPr>
                <a:xfrm>
                  <a:off x="6569756" y="1371560"/>
                  <a:ext cx="152400" cy="152400"/>
                </a:xfrm>
                <a:prstGeom prst="rect">
                  <a:avLst/>
                </a:prstGeom>
                <a:solidFill>
                  <a:srgbClr val="38572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800" dirty="0"/>
                </a:p>
              </p:txBody>
            </p:sp>
            <p:sp>
              <p:nvSpPr>
                <p:cNvPr id="117" name="Rectangle 116">
                  <a:extLst>
                    <a:ext uri="{FF2B5EF4-FFF2-40B4-BE49-F238E27FC236}">
                      <a16:creationId xmlns:a16="http://schemas.microsoft.com/office/drawing/2014/main" id="{AD3045DA-26B3-416D-B589-425D37751EEF}"/>
                    </a:ext>
                  </a:extLst>
                </p:cNvPr>
                <p:cNvSpPr/>
                <p:nvPr/>
              </p:nvSpPr>
              <p:spPr>
                <a:xfrm>
                  <a:off x="6376461" y="1371560"/>
                  <a:ext cx="152400" cy="152400"/>
                </a:xfrm>
                <a:prstGeom prst="rect">
                  <a:avLst/>
                </a:prstGeom>
                <a:solidFill>
                  <a:srgbClr val="A9D18E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800" dirty="0"/>
                </a:p>
              </p:txBody>
            </p:sp>
          </p:grpSp>
          <p:sp>
            <p:nvSpPr>
              <p:cNvPr id="119" name="Rectangle 118">
                <a:extLst>
                  <a:ext uri="{FF2B5EF4-FFF2-40B4-BE49-F238E27FC236}">
                    <a16:creationId xmlns:a16="http://schemas.microsoft.com/office/drawing/2014/main" id="{A64CD0E0-ECF7-4C99-B223-47ED965E18F2}"/>
                  </a:ext>
                </a:extLst>
              </p:cNvPr>
              <p:cNvSpPr/>
              <p:nvPr/>
            </p:nvSpPr>
            <p:spPr>
              <a:xfrm>
                <a:off x="6477396" y="1583871"/>
                <a:ext cx="152400" cy="152400"/>
              </a:xfrm>
              <a:prstGeom prst="rect">
                <a:avLst/>
              </a:prstGeom>
              <a:solidFill>
                <a:srgbClr val="0066CC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4A7708C6-7334-4D20-AECE-8C59EAB423E8}"/>
                  </a:ext>
                </a:extLst>
              </p:cNvPr>
              <p:cNvSpPr/>
              <p:nvPr/>
            </p:nvSpPr>
            <p:spPr>
              <a:xfrm>
                <a:off x="6477396" y="1795875"/>
                <a:ext cx="152400" cy="152400"/>
              </a:xfrm>
              <a:prstGeom prst="rect">
                <a:avLst/>
              </a:prstGeom>
              <a:solidFill>
                <a:srgbClr val="7030A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5A631DE6-4F56-485D-BDA2-89B41F74FC87}"/>
                  </a:ext>
                </a:extLst>
              </p:cNvPr>
              <p:cNvSpPr txBox="1"/>
              <p:nvPr/>
            </p:nvSpPr>
            <p:spPr>
              <a:xfrm>
                <a:off x="6710487" y="931866"/>
                <a:ext cx="1321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ecretory Signal Peptide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77122AB3-B699-4E31-8495-4BBF6D32F44F}"/>
                  </a:ext>
                </a:extLst>
              </p:cNvPr>
              <p:cNvSpPr txBox="1"/>
              <p:nvPr/>
            </p:nvSpPr>
            <p:spPr>
              <a:xfrm>
                <a:off x="6710487" y="1129513"/>
                <a:ext cx="6142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T-Als + 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3D6BAD10-97E9-45DE-8BBA-B3937CB27DD6}"/>
                  </a:ext>
                </a:extLst>
              </p:cNvPr>
              <p:cNvSpPr txBox="1"/>
              <p:nvPr/>
            </p:nvSpPr>
            <p:spPr>
              <a:xfrm>
                <a:off x="6710487" y="1336497"/>
                <a:ext cx="9765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ndem Repeats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9C6E7825-36E3-4C31-9FDF-7C6C07353111}"/>
                  </a:ext>
                </a:extLst>
              </p:cNvPr>
              <p:cNvSpPr txBox="1"/>
              <p:nvPr/>
            </p:nvSpPr>
            <p:spPr>
              <a:xfrm>
                <a:off x="6710487" y="1771727"/>
                <a:ext cx="97174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PI Addition Site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C76E54CF-1C0A-4456-BCF5-DB83573196F2}"/>
                  </a:ext>
                </a:extLst>
              </p:cNvPr>
              <p:cNvSpPr txBox="1"/>
              <p:nvPr/>
            </p:nvSpPr>
            <p:spPr>
              <a:xfrm>
                <a:off x="6710487" y="1543750"/>
                <a:ext cx="7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ch</a:t>
                </a:r>
              </a:p>
            </p:txBody>
          </p: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0EA1792D-8B14-4DB2-BCDE-DB05BBE3AE3B}"/>
                </a:ext>
              </a:extLst>
            </p:cNvPr>
            <p:cNvGrpSpPr/>
            <p:nvPr/>
          </p:nvGrpSpPr>
          <p:grpSpPr>
            <a:xfrm>
              <a:off x="938850" y="909099"/>
              <a:ext cx="5434067" cy="1493888"/>
              <a:chOff x="938850" y="909099"/>
              <a:chExt cx="5434067" cy="1493888"/>
            </a:xfrm>
          </p:grpSpPr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122C6EE1-7C75-4DE7-ACA1-7B7478F3CB6E}"/>
                  </a:ext>
                </a:extLst>
              </p:cNvPr>
              <p:cNvGrpSpPr/>
              <p:nvPr/>
            </p:nvGrpSpPr>
            <p:grpSpPr>
              <a:xfrm>
                <a:off x="938850" y="909099"/>
                <a:ext cx="5434067" cy="458861"/>
                <a:chOff x="337304" y="1026064"/>
                <a:chExt cx="5434067" cy="458861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E1CC8FBC-C940-4F8C-8B1D-269BFBEAFAB5}"/>
                    </a:ext>
                  </a:extLst>
                </p:cNvPr>
                <p:cNvSpPr txBox="1"/>
                <p:nvPr/>
              </p:nvSpPr>
              <p:spPr>
                <a:xfrm>
                  <a:off x="337304" y="1026064"/>
                  <a:ext cx="106895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auAls2582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Rectangle 127">
                  <a:extLst>
                    <a:ext uri="{FF2B5EF4-FFF2-40B4-BE49-F238E27FC236}">
                      <a16:creationId xmlns:a16="http://schemas.microsoft.com/office/drawing/2014/main" id="{824E47CC-CB90-4275-94FC-18A57D89BF2E}"/>
                    </a:ext>
                  </a:extLst>
                </p:cNvPr>
                <p:cNvSpPr/>
                <p:nvPr/>
              </p:nvSpPr>
              <p:spPr>
                <a:xfrm>
                  <a:off x="528156" y="1256325"/>
                  <a:ext cx="45720" cy="228600"/>
                </a:xfrm>
                <a:prstGeom prst="rect">
                  <a:avLst/>
                </a:prstGeom>
                <a:solidFill>
                  <a:srgbClr val="FFC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accent4"/>
                    </a:solidFill>
                  </a:endParaRPr>
                </a:p>
              </p:txBody>
            </p:sp>
            <p:sp>
              <p:nvSpPr>
                <p:cNvPr id="129" name="Rectangle 128">
                  <a:extLst>
                    <a:ext uri="{FF2B5EF4-FFF2-40B4-BE49-F238E27FC236}">
                      <a16:creationId xmlns:a16="http://schemas.microsoft.com/office/drawing/2014/main" id="{57130DC9-C168-406B-A671-4A916B5EE5CF}"/>
                    </a:ext>
                  </a:extLst>
                </p:cNvPr>
                <p:cNvSpPr/>
                <p:nvPr/>
              </p:nvSpPr>
              <p:spPr>
                <a:xfrm>
                  <a:off x="570355" y="1256325"/>
                  <a:ext cx="758952" cy="228600"/>
                </a:xfrm>
                <a:prstGeom prst="rect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0" name="Rectangle 129">
                  <a:extLst>
                    <a:ext uri="{FF2B5EF4-FFF2-40B4-BE49-F238E27FC236}">
                      <a16:creationId xmlns:a16="http://schemas.microsoft.com/office/drawing/2014/main" id="{D6F8BF60-A1E7-43DB-B7B9-ABA883130456}"/>
                    </a:ext>
                  </a:extLst>
                </p:cNvPr>
                <p:cNvSpPr/>
                <p:nvPr/>
              </p:nvSpPr>
              <p:spPr>
                <a:xfrm>
                  <a:off x="1334353" y="1256325"/>
                  <a:ext cx="1197864" cy="228600"/>
                </a:xfrm>
                <a:prstGeom prst="rect">
                  <a:avLst/>
                </a:prstGeom>
                <a:solidFill>
                  <a:srgbClr val="0066CC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1" name="Rectangle 130">
                  <a:extLst>
                    <a:ext uri="{FF2B5EF4-FFF2-40B4-BE49-F238E27FC236}">
                      <a16:creationId xmlns:a16="http://schemas.microsoft.com/office/drawing/2014/main" id="{87AB9E63-6A40-4ED1-B3AC-0A4639DEBB54}"/>
                    </a:ext>
                  </a:extLst>
                </p:cNvPr>
                <p:cNvSpPr/>
                <p:nvPr/>
              </p:nvSpPr>
              <p:spPr>
                <a:xfrm>
                  <a:off x="2540207" y="1256325"/>
                  <a:ext cx="45720" cy="228600"/>
                </a:xfrm>
                <a:prstGeom prst="rect">
                  <a:avLst/>
                </a:prstGeom>
                <a:solidFill>
                  <a:srgbClr val="7030A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7030A0"/>
                    </a:solidFill>
                  </a:endParaRP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5EAE5B41-FD27-4F25-B545-260FF45BDEDF}"/>
                    </a:ext>
                  </a:extLst>
                </p:cNvPr>
                <p:cNvSpPr txBox="1"/>
                <p:nvPr/>
              </p:nvSpPr>
              <p:spPr>
                <a:xfrm>
                  <a:off x="1197683" y="1028794"/>
                  <a:ext cx="457368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Gene is on scaffold 9; </a:t>
                  </a:r>
                  <a:r>
                    <a:rPr lang="en-US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767,294 to 769,879 of 776,876 total = </a:t>
                  </a:r>
                  <a:r>
                    <a:rPr lang="en-US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ubtelomeric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location)</a:t>
                  </a:r>
                </a:p>
              </p:txBody>
            </p:sp>
          </p:grp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AACEBEBB-4724-4C7C-9D08-C694EEE8981B}"/>
                  </a:ext>
                </a:extLst>
              </p:cNvPr>
              <p:cNvGrpSpPr/>
              <p:nvPr/>
            </p:nvGrpSpPr>
            <p:grpSpPr>
              <a:xfrm>
                <a:off x="938850" y="1423556"/>
                <a:ext cx="4107454" cy="246221"/>
                <a:chOff x="938850" y="1423556"/>
                <a:chExt cx="4107454" cy="246221"/>
              </a:xfrm>
            </p:grpSpPr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2647DDF4-759B-481A-ABF3-7AA8F7097C11}"/>
                    </a:ext>
                  </a:extLst>
                </p:cNvPr>
                <p:cNvSpPr txBox="1"/>
                <p:nvPr/>
              </p:nvSpPr>
              <p:spPr>
                <a:xfrm>
                  <a:off x="938850" y="1423556"/>
                  <a:ext cx="106895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auAls4112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314643C1-F3A7-490C-81A7-163F141171E6}"/>
                    </a:ext>
                  </a:extLst>
                </p:cNvPr>
                <p:cNvSpPr txBox="1"/>
                <p:nvPr/>
              </p:nvSpPr>
              <p:spPr>
                <a:xfrm>
                  <a:off x="1815932" y="1428416"/>
                  <a:ext cx="323037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Gene is on scaffold 7; </a:t>
                  </a:r>
                  <a:r>
                    <a:rPr lang="en-US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41,482 to 46,869 of 898,131 total)</a:t>
                  </a:r>
                </a:p>
              </p:txBody>
            </p:sp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A4A5C4BE-FC8B-4552-8C1A-0E54BDF0379E}"/>
                  </a:ext>
                </a:extLst>
              </p:cNvPr>
              <p:cNvGrpSpPr/>
              <p:nvPr/>
            </p:nvGrpSpPr>
            <p:grpSpPr>
              <a:xfrm>
                <a:off x="938850" y="1959770"/>
                <a:ext cx="4189616" cy="443217"/>
                <a:chOff x="352052" y="2349573"/>
                <a:chExt cx="4189616" cy="443217"/>
              </a:xfrm>
            </p:grpSpPr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1A3E89F4-C4B6-4841-8591-52F344026312}"/>
                    </a:ext>
                  </a:extLst>
                </p:cNvPr>
                <p:cNvGrpSpPr/>
                <p:nvPr/>
              </p:nvGrpSpPr>
              <p:grpSpPr>
                <a:xfrm>
                  <a:off x="538474" y="2564190"/>
                  <a:ext cx="2088109" cy="228600"/>
                  <a:chOff x="538474" y="2564190"/>
                  <a:chExt cx="2088109" cy="228600"/>
                </a:xfrm>
              </p:grpSpPr>
              <p:sp>
                <p:nvSpPr>
                  <p:cNvPr id="143" name="Rectangle 142">
                    <a:extLst>
                      <a:ext uri="{FF2B5EF4-FFF2-40B4-BE49-F238E27FC236}">
                        <a16:creationId xmlns:a16="http://schemas.microsoft.com/office/drawing/2014/main" id="{C47E2483-C54A-41E7-AA73-352842FB1411}"/>
                      </a:ext>
                    </a:extLst>
                  </p:cNvPr>
                  <p:cNvSpPr/>
                  <p:nvPr/>
                </p:nvSpPr>
                <p:spPr>
                  <a:xfrm>
                    <a:off x="538474" y="2564190"/>
                    <a:ext cx="45720" cy="228600"/>
                  </a:xfrm>
                  <a:prstGeom prst="rect">
                    <a:avLst/>
                  </a:prstGeom>
                  <a:solidFill>
                    <a:srgbClr val="FFC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accent4"/>
                      </a:solidFill>
                    </a:endParaRPr>
                  </a:p>
                </p:txBody>
              </p:sp>
              <p:sp>
                <p:nvSpPr>
                  <p:cNvPr id="144" name="Rectangle 143">
                    <a:extLst>
                      <a:ext uri="{FF2B5EF4-FFF2-40B4-BE49-F238E27FC236}">
                        <a16:creationId xmlns:a16="http://schemas.microsoft.com/office/drawing/2014/main" id="{85D7181C-FAB7-45BF-BA71-34B092335DD1}"/>
                      </a:ext>
                    </a:extLst>
                  </p:cNvPr>
                  <p:cNvSpPr/>
                  <p:nvPr/>
                </p:nvSpPr>
                <p:spPr>
                  <a:xfrm>
                    <a:off x="585286" y="2564190"/>
                    <a:ext cx="758952" cy="228600"/>
                  </a:xfrm>
                  <a:prstGeom prst="rect">
                    <a:avLst/>
                  </a:prstGeom>
                  <a:solidFill>
                    <a:srgbClr val="FF0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6" name="Rectangle 145">
                    <a:extLst>
                      <a:ext uri="{FF2B5EF4-FFF2-40B4-BE49-F238E27FC236}">
                        <a16:creationId xmlns:a16="http://schemas.microsoft.com/office/drawing/2014/main" id="{37B65952-E15B-493B-B154-8E7B2C06B660}"/>
                      </a:ext>
                    </a:extLst>
                  </p:cNvPr>
                  <p:cNvSpPr/>
                  <p:nvPr/>
                </p:nvSpPr>
                <p:spPr>
                  <a:xfrm>
                    <a:off x="1345330" y="2564190"/>
                    <a:ext cx="1197864" cy="228600"/>
                  </a:xfrm>
                  <a:prstGeom prst="rect">
                    <a:avLst/>
                  </a:prstGeom>
                  <a:solidFill>
                    <a:srgbClr val="0066CC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7" name="Rectangle 146">
                    <a:extLst>
                      <a:ext uri="{FF2B5EF4-FFF2-40B4-BE49-F238E27FC236}">
                        <a16:creationId xmlns:a16="http://schemas.microsoft.com/office/drawing/2014/main" id="{96862306-C0E3-4BB9-82D2-C095A6393142}"/>
                      </a:ext>
                    </a:extLst>
                  </p:cNvPr>
                  <p:cNvSpPr/>
                  <p:nvPr/>
                </p:nvSpPr>
                <p:spPr>
                  <a:xfrm>
                    <a:off x="2544287" y="2564190"/>
                    <a:ext cx="82296" cy="228600"/>
                  </a:xfrm>
                  <a:prstGeom prst="rect">
                    <a:avLst/>
                  </a:prstGeom>
                  <a:solidFill>
                    <a:srgbClr val="7030A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rgbClr val="7030A0"/>
                      </a:solidFill>
                    </a:endParaRPr>
                  </a:p>
                </p:txBody>
              </p:sp>
            </p:grpSp>
            <p:sp>
              <p:nvSpPr>
                <p:cNvPr id="148" name="TextBox 147">
                  <a:extLst>
                    <a:ext uri="{FF2B5EF4-FFF2-40B4-BE49-F238E27FC236}">
                      <a16:creationId xmlns:a16="http://schemas.microsoft.com/office/drawing/2014/main" id="{2DD5EAD8-4FB2-456A-A086-02C5714BB7AF}"/>
                    </a:ext>
                  </a:extLst>
                </p:cNvPr>
                <p:cNvSpPr txBox="1"/>
                <p:nvPr/>
              </p:nvSpPr>
              <p:spPr>
                <a:xfrm>
                  <a:off x="352052" y="2349573"/>
                  <a:ext cx="106895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auAls4498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F1908149-5C16-4FE0-A525-9D8B373E5AB5}"/>
                    </a:ext>
                  </a:extLst>
                </p:cNvPr>
                <p:cNvSpPr txBox="1"/>
                <p:nvPr/>
              </p:nvSpPr>
              <p:spPr>
                <a:xfrm>
                  <a:off x="1215116" y="2357267"/>
                  <a:ext cx="332655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Gene is on scaffold 6; </a:t>
                  </a:r>
                  <a:r>
                    <a:rPr lang="en-US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76,557 to 79,076 of 1,007,143 total)</a:t>
                  </a:r>
                </a:p>
              </p:txBody>
            </p:sp>
          </p:grpSp>
        </p:grp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9D1587FB-109F-4062-81A4-48AA997C901E}"/>
              </a:ext>
            </a:extLst>
          </p:cNvPr>
          <p:cNvSpPr txBox="1"/>
          <p:nvPr/>
        </p:nvSpPr>
        <p:spPr>
          <a:xfrm>
            <a:off x="1648583" y="49969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364D96C-2D02-42BA-BDFF-BD72C91C85C8}"/>
              </a:ext>
            </a:extLst>
          </p:cNvPr>
          <p:cNvSpPr txBox="1"/>
          <p:nvPr/>
        </p:nvSpPr>
        <p:spPr>
          <a:xfrm>
            <a:off x="1029223" y="61829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E5BC7FB-CFCE-4CA0-8F30-3BA5EC6FE6A5}"/>
              </a:ext>
            </a:extLst>
          </p:cNvPr>
          <p:cNvSpPr txBox="1"/>
          <p:nvPr/>
        </p:nvSpPr>
        <p:spPr>
          <a:xfrm>
            <a:off x="1248781" y="30473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0902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E574193-001F-4EB9-9CCB-6AE236996AEE}"/>
              </a:ext>
            </a:extLst>
          </p:cNvPr>
          <p:cNvSpPr txBox="1"/>
          <p:nvPr/>
        </p:nvSpPr>
        <p:spPr>
          <a:xfrm>
            <a:off x="790739" y="553889"/>
            <a:ext cx="729681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|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r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feature summary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ine drawings to illustrate the basic features of the Als proteins predicted from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r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sequence and validated by PCR amplification/Sanger sequencing. Genome assembl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d_auris_B8441_V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ordinates were referenced above each drawing. A color-coding key and scale bar are shown. The red region in each drawing corresponded to the NT-Als domain; the “+” designation referred to inclusion of sequences C-terminal to NT-Als (i.e. the red region ends where repeated sequences or Ser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ch sequences began)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uAls411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the only protein with a central domain of repeated sequence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Repeat lengths varied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uAls411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Dash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ded to the 35-aa sequence to align it with the 39-aa consensu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cent identity values for comparisons among the NT-Als sequences for each protein calculat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mega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deira et al., 20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included for reference because its crystallographic structure is known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 et al., 201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3339563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4</TotalTime>
  <Words>423</Words>
  <Application>Microsoft Office PowerPoint</Application>
  <PresentationFormat>On-screen Show (4:3)</PresentationFormat>
  <Paragraphs>4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is Hoyer</dc:creator>
  <cp:lastModifiedBy>Lois Hoyer</cp:lastModifiedBy>
  <cp:revision>3</cp:revision>
  <dcterms:created xsi:type="dcterms:W3CDTF">2021-08-31T18:47:01Z</dcterms:created>
  <dcterms:modified xsi:type="dcterms:W3CDTF">2021-10-03T16:05:59Z</dcterms:modified>
</cp:coreProperties>
</file>